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17" autoAdjust="0"/>
    <p:restoredTop sz="94660"/>
  </p:normalViewPr>
  <p:slideViewPr>
    <p:cSldViewPr snapToGrid="0">
      <p:cViewPr varScale="1">
        <p:scale>
          <a:sx n="78" d="100"/>
          <a:sy n="78" d="100"/>
        </p:scale>
        <p:origin x="878"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一燈 下川" userId="eb6a0abbb11b9709" providerId="LiveId" clId="{BA8A3260-AAC7-4F00-8A69-3761BD23F087}"/>
    <pc:docChg chg="modSld">
      <pc:chgData name="一燈 下川" userId="eb6a0abbb11b9709" providerId="LiveId" clId="{BA8A3260-AAC7-4F00-8A69-3761BD23F087}" dt="2025-03-26T05:21:14.038" v="5" actId="1076"/>
      <pc:docMkLst>
        <pc:docMk/>
      </pc:docMkLst>
      <pc:sldChg chg="addSp modSp mod">
        <pc:chgData name="一燈 下川" userId="eb6a0abbb11b9709" providerId="LiveId" clId="{BA8A3260-AAC7-4F00-8A69-3761BD23F087}" dt="2025-03-26T05:21:14.038" v="5" actId="1076"/>
        <pc:sldMkLst>
          <pc:docMk/>
          <pc:sldMk cId="1106325831" sldId="256"/>
        </pc:sldMkLst>
        <pc:spChg chg="add mod">
          <ac:chgData name="一燈 下川" userId="eb6a0abbb11b9709" providerId="LiveId" clId="{BA8A3260-AAC7-4F00-8A69-3761BD23F087}" dt="2025-03-26T05:21:14.038" v="5" actId="1076"/>
          <ac:spMkLst>
            <pc:docMk/>
            <pc:sldMk cId="1106325831" sldId="256"/>
            <ac:spMk id="3" creationId="{82A4F2B2-9E4A-46DA-49B0-4BEADE018666}"/>
          </ac:spMkLst>
        </pc:spChg>
        <pc:picChg chg="mod">
          <ac:chgData name="一燈 下川" userId="eb6a0abbb11b9709" providerId="LiveId" clId="{BA8A3260-AAC7-4F00-8A69-3761BD23F087}" dt="2025-03-26T05:21:05.741" v="2" actId="1076"/>
          <ac:picMkLst>
            <pc:docMk/>
            <pc:sldMk cId="1106325831" sldId="256"/>
            <ac:picMk id="9" creationId="{0FB411C0-40C8-9E67-71D5-8F1CD0D7643A}"/>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84D8C84-D8C0-EA50-96A1-E91DF21B674C}"/>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AE0A9CEB-13AA-ACEF-FE46-618D79D2B07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5E7C9CFD-8092-28AB-0B74-61468FE97A51}"/>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5" name="フッター プレースホルダー 4">
            <a:extLst>
              <a:ext uri="{FF2B5EF4-FFF2-40B4-BE49-F238E27FC236}">
                <a16:creationId xmlns:a16="http://schemas.microsoft.com/office/drawing/2014/main" id="{305BAC29-FA5D-338E-ECCB-177E376D5A7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76F4D70-D1E4-29A8-E1CE-ACCF95D1156C}"/>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2448853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C72CD96-5D89-6BDE-23E7-780042119C3B}"/>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D0768464-F5B4-3EDD-D331-370CEDE7F716}"/>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B18C777-5D16-5A26-7A44-B404D53B558F}"/>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5" name="フッター プレースホルダー 4">
            <a:extLst>
              <a:ext uri="{FF2B5EF4-FFF2-40B4-BE49-F238E27FC236}">
                <a16:creationId xmlns:a16="http://schemas.microsoft.com/office/drawing/2014/main" id="{080FE5BF-714D-12DA-086B-5158D0C398C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058BFE9-F468-3A86-5FDE-CC5ABF26FB22}"/>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3553155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8D1DBBCB-3E12-D646-A966-CC59A9773B31}"/>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3E509685-81CD-FC01-EF11-B8816DB4AC03}"/>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98624A7-6C57-8C9B-DB14-7C93600506FA}"/>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5" name="フッター プレースホルダー 4">
            <a:extLst>
              <a:ext uri="{FF2B5EF4-FFF2-40B4-BE49-F238E27FC236}">
                <a16:creationId xmlns:a16="http://schemas.microsoft.com/office/drawing/2014/main" id="{B8FBE044-1460-C320-0318-58757F352C45}"/>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F230EB9-6D93-04D9-D9D7-20E6656363AF}"/>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29653662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C648A40-30A8-24E0-2F25-486E7AEC7319}"/>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238AE3E-0762-3997-C8F2-1F42C4E74D36}"/>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7F88805-CFD8-043A-B442-9A741E6BB30F}"/>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5" name="フッター プレースホルダー 4">
            <a:extLst>
              <a:ext uri="{FF2B5EF4-FFF2-40B4-BE49-F238E27FC236}">
                <a16:creationId xmlns:a16="http://schemas.microsoft.com/office/drawing/2014/main" id="{35644E52-12AF-875C-4A06-816E9CECE49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59FF057E-F3E7-E473-6CA8-88441138192F}"/>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1615481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D2FB16E-A70D-7AEF-2D13-DA53AF852F54}"/>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E517CC26-F811-610E-D91B-44E701956363}"/>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ECC24DAA-7FCB-4860-5886-CE7C9EF735FB}"/>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5" name="フッター プレースホルダー 4">
            <a:extLst>
              <a:ext uri="{FF2B5EF4-FFF2-40B4-BE49-F238E27FC236}">
                <a16:creationId xmlns:a16="http://schemas.microsoft.com/office/drawing/2014/main" id="{60322913-473E-D82E-CA65-A6BBE3876A7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CA5D02B-E1DB-A2B3-12BF-54B1A56466A6}"/>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31168116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22AE6A1-D818-4E51-7BAE-1B89E94C7738}"/>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341391E0-BA6C-BB02-4FEE-F025AB887FD9}"/>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F3456D23-B0D6-9B15-91D5-756070B09596}"/>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1C0E07E3-B79B-720B-8773-D8DF309B3F4E}"/>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6" name="フッター プレースホルダー 5">
            <a:extLst>
              <a:ext uri="{FF2B5EF4-FFF2-40B4-BE49-F238E27FC236}">
                <a16:creationId xmlns:a16="http://schemas.microsoft.com/office/drawing/2014/main" id="{55AFADF4-6C1C-78BF-B986-3FEFFF9555EF}"/>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E6147EDB-CCB3-B325-444A-373E14B0EAC5}"/>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41206520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34DD9E1-280F-FAB7-76E1-94370770DE45}"/>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0E5ADFBC-6DBE-50ED-5217-951FAE55B60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C5A76A32-348B-C211-9533-56B4D5ADF285}"/>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D5E15A93-A189-692B-4143-B80656F542C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03EC4D6D-0C8B-802F-A33D-3F3859DE2B6F}"/>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BEA50783-263F-6971-3A66-FB1C719A8157}"/>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8" name="フッター プレースホルダー 7">
            <a:extLst>
              <a:ext uri="{FF2B5EF4-FFF2-40B4-BE49-F238E27FC236}">
                <a16:creationId xmlns:a16="http://schemas.microsoft.com/office/drawing/2014/main" id="{1B3CA1C0-4066-788C-7F24-D47680C733E8}"/>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19C846A4-727D-4410-17DA-AE1210A3E330}"/>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7068200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552F5A6-624B-BC63-5CAC-4EBDEC348A44}"/>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5D02F045-765A-1840-D138-67657841E398}"/>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4" name="フッター プレースホルダー 3">
            <a:extLst>
              <a:ext uri="{FF2B5EF4-FFF2-40B4-BE49-F238E27FC236}">
                <a16:creationId xmlns:a16="http://schemas.microsoft.com/office/drawing/2014/main" id="{C1A1CC9C-8DCA-9AE5-510D-705ECC124323}"/>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2E9D68D5-29AB-089B-5C65-B843BE9B2D80}"/>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27776520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B7382642-C3B3-53F3-1569-7181A1B49C22}"/>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3" name="フッター プレースホルダー 2">
            <a:extLst>
              <a:ext uri="{FF2B5EF4-FFF2-40B4-BE49-F238E27FC236}">
                <a16:creationId xmlns:a16="http://schemas.microsoft.com/office/drawing/2014/main" id="{7EBDA16A-8B7E-2413-5EC3-69A9E5273662}"/>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2344EE43-A007-A2CB-FC97-6E6B96F52DB3}"/>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41551730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FB9C92B-62FF-CF47-224A-5F7AEC5420F5}"/>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0A55B908-AC75-D976-498E-BDCCC2E6FC4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26BB3A87-EA75-148F-AEAF-BA1596575E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6763B641-A5C6-12E1-2BC1-69074727CF42}"/>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6" name="フッター プレースホルダー 5">
            <a:extLst>
              <a:ext uri="{FF2B5EF4-FFF2-40B4-BE49-F238E27FC236}">
                <a16:creationId xmlns:a16="http://schemas.microsoft.com/office/drawing/2014/main" id="{7CA8953B-1CBD-C7A2-9815-0BC538B9381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4B08016A-B46D-25AF-138F-19C97E809B6F}"/>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25340316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00CC420-A6A3-0F1D-7B3C-1D32803E25CD}"/>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924E3DA2-808F-68C3-13CB-6B80E21DC97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25A91FAF-C5D6-876E-865D-637CAD70BFA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85246CDC-0245-05ED-572B-FA83A03EA3F1}"/>
              </a:ext>
            </a:extLst>
          </p:cNvPr>
          <p:cNvSpPr>
            <a:spLocks noGrp="1"/>
          </p:cNvSpPr>
          <p:nvPr>
            <p:ph type="dt" sz="half" idx="10"/>
          </p:nvPr>
        </p:nvSpPr>
        <p:spPr/>
        <p:txBody>
          <a:bodyPr/>
          <a:lstStyle/>
          <a:p>
            <a:fld id="{A833B3A8-9452-48A6-9149-056AED8A4B42}" type="datetimeFigureOut">
              <a:rPr kumimoji="1" lang="ja-JP" altLang="en-US" smtClean="0"/>
              <a:t>2025/3/26</a:t>
            </a:fld>
            <a:endParaRPr kumimoji="1" lang="ja-JP" altLang="en-US"/>
          </a:p>
        </p:txBody>
      </p:sp>
      <p:sp>
        <p:nvSpPr>
          <p:cNvPr id="6" name="フッター プレースホルダー 5">
            <a:extLst>
              <a:ext uri="{FF2B5EF4-FFF2-40B4-BE49-F238E27FC236}">
                <a16:creationId xmlns:a16="http://schemas.microsoft.com/office/drawing/2014/main" id="{07139A95-D94B-4CA0-1C47-89C8D4CBDFE0}"/>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183246C9-48A0-4B37-8F7B-90025C9BC6DD}"/>
              </a:ext>
            </a:extLst>
          </p:cNvPr>
          <p:cNvSpPr>
            <a:spLocks noGrp="1"/>
          </p:cNvSpPr>
          <p:nvPr>
            <p:ph type="sldNum" sz="quarter" idx="12"/>
          </p:nvPr>
        </p:nvSpPr>
        <p:spPr/>
        <p:txBody>
          <a:body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41740154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5FC290ED-0C3E-66B3-879B-5C81196EA3D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DEBF58F1-4EBB-1CAE-E498-A5C39D51489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CF00AC9A-9DCB-A752-AA9E-0ECEA0A3C6B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A833B3A8-9452-48A6-9149-056AED8A4B42}" type="datetimeFigureOut">
              <a:rPr kumimoji="1" lang="ja-JP" altLang="en-US" smtClean="0"/>
              <a:t>2025/3/26</a:t>
            </a:fld>
            <a:endParaRPr kumimoji="1" lang="ja-JP" altLang="en-US"/>
          </a:p>
        </p:txBody>
      </p:sp>
      <p:sp>
        <p:nvSpPr>
          <p:cNvPr id="5" name="フッター プレースホルダー 4">
            <a:extLst>
              <a:ext uri="{FF2B5EF4-FFF2-40B4-BE49-F238E27FC236}">
                <a16:creationId xmlns:a16="http://schemas.microsoft.com/office/drawing/2014/main" id="{45336764-E992-2727-9B9D-29003C2B911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22360CC6-1938-8003-39EB-C034A6D5CC5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C09C4F4B-AF9B-4655-B372-C77879326806}" type="slidenum">
              <a:rPr kumimoji="1" lang="ja-JP" altLang="en-US" smtClean="0"/>
              <a:t>‹#›</a:t>
            </a:fld>
            <a:endParaRPr kumimoji="1" lang="ja-JP" altLang="en-US"/>
          </a:p>
        </p:txBody>
      </p:sp>
    </p:spTree>
    <p:extLst>
      <p:ext uri="{BB962C8B-B14F-4D97-AF65-F5344CB8AC3E}">
        <p14:creationId xmlns:p14="http://schemas.microsoft.com/office/powerpoint/2010/main" val="25383535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図 8">
            <a:extLst>
              <a:ext uri="{FF2B5EF4-FFF2-40B4-BE49-F238E27FC236}">
                <a16:creationId xmlns:a16="http://schemas.microsoft.com/office/drawing/2014/main" id="{0FB411C0-40C8-9E67-71D5-8F1CD0D7643A}"/>
              </a:ext>
            </a:extLst>
          </p:cNvPr>
          <p:cNvPicPr>
            <a:picLocks noChangeAspect="1"/>
          </p:cNvPicPr>
          <p:nvPr/>
        </p:nvPicPr>
        <p:blipFill>
          <a:blip r:embed="rId2"/>
          <a:stretch>
            <a:fillRect/>
          </a:stretch>
        </p:blipFill>
        <p:spPr>
          <a:xfrm>
            <a:off x="2876301" y="0"/>
            <a:ext cx="6651158" cy="5843746"/>
          </a:xfrm>
          <a:prstGeom prst="rect">
            <a:avLst/>
          </a:prstGeom>
        </p:spPr>
      </p:pic>
      <p:sp>
        <p:nvSpPr>
          <p:cNvPr id="3" name="テキスト ボックス 2">
            <a:extLst>
              <a:ext uri="{FF2B5EF4-FFF2-40B4-BE49-F238E27FC236}">
                <a16:creationId xmlns:a16="http://schemas.microsoft.com/office/drawing/2014/main" id="{82A4F2B2-9E4A-46DA-49B0-4BEADE018666}"/>
              </a:ext>
            </a:extLst>
          </p:cNvPr>
          <p:cNvSpPr txBox="1"/>
          <p:nvPr/>
        </p:nvSpPr>
        <p:spPr>
          <a:xfrm>
            <a:off x="1799302" y="5740794"/>
            <a:ext cx="9930581" cy="923330"/>
          </a:xfrm>
          <a:prstGeom prst="rect">
            <a:avLst/>
          </a:prstGeom>
          <a:noFill/>
        </p:spPr>
        <p:txBody>
          <a:bodyPr wrap="square">
            <a:spAutoFit/>
          </a:bodyPr>
          <a:lstStyle/>
          <a:p>
            <a:r>
              <a:rPr lang="en-US" altLang="ja-JP" sz="1800" b="1" i="0" dirty="0">
                <a:solidFill>
                  <a:srgbClr val="000000"/>
                </a:solidFill>
                <a:effectLst/>
                <a:latin typeface="Times New Roman" panose="02020603050405020304" pitchFamily="18" charset="0"/>
              </a:rPr>
              <a:t>Supplementary Figure S2</a:t>
            </a:r>
            <a:r>
              <a:rPr lang="en-US" altLang="ja-JP" sz="1800" b="1" i="0" dirty="0">
                <a:solidFill>
                  <a:srgbClr val="000000"/>
                </a:solidFill>
                <a:effectLst/>
                <a:ea typeface="Times New Roman" panose="02020603050405020304" pitchFamily="18" charset="0"/>
              </a:rPr>
              <a:t>.</a:t>
            </a:r>
            <a:r>
              <a:rPr lang="en-US" altLang="ja-JP" sz="1800" b="0" i="0" dirty="0">
                <a:solidFill>
                  <a:srgbClr val="000000"/>
                </a:solidFill>
                <a:effectLst/>
                <a:ea typeface="Times New Roman" panose="02020603050405020304" pitchFamily="18" charset="0"/>
              </a:rPr>
              <a:t> </a:t>
            </a:r>
            <a:r>
              <a:rPr lang="en-US" altLang="ja-JP" sz="1800" b="0" i="0" dirty="0">
                <a:solidFill>
                  <a:srgbClr val="000000"/>
                </a:solidFill>
                <a:effectLst/>
                <a:latin typeface="Times New Roman" panose="02020603050405020304" pitchFamily="18" charset="0"/>
              </a:rPr>
              <a:t>Confusion matrix of the validation cases for the Yolov5x model annotated with both benign and malignant categories. This matrix presents the model's performance in distinguishing between benign and malignant cases in the validation dataset. </a:t>
            </a:r>
            <a:endParaRPr lang="ja-JP" altLang="en-US" dirty="0"/>
          </a:p>
        </p:txBody>
      </p:sp>
    </p:spTree>
    <p:extLst>
      <p:ext uri="{BB962C8B-B14F-4D97-AF65-F5344CB8AC3E}">
        <p14:creationId xmlns:p14="http://schemas.microsoft.com/office/powerpoint/2010/main" val="1106325831"/>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8</TotalTime>
  <Words>40</Words>
  <Application>Microsoft Office PowerPoint</Application>
  <PresentationFormat>ワイド画面</PresentationFormat>
  <Paragraphs>1</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游ゴシック</vt:lpstr>
      <vt:lpstr>游ゴシック Light</vt:lpstr>
      <vt:lpstr>Arial</vt:lpstr>
      <vt:lpstr>Times New Roman</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一燈 下川</dc:creator>
  <cp:lastModifiedBy>一燈 下川</cp:lastModifiedBy>
  <cp:revision>1</cp:revision>
  <dcterms:created xsi:type="dcterms:W3CDTF">2024-10-30T04:35:02Z</dcterms:created>
  <dcterms:modified xsi:type="dcterms:W3CDTF">2025-03-26T05:21:16Z</dcterms:modified>
</cp:coreProperties>
</file>